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66"/>
    <p:restoredTop sz="92987"/>
  </p:normalViewPr>
  <p:slideViewPr>
    <p:cSldViewPr snapToGrid="0" snapToObjects="1">
      <p:cViewPr varScale="1">
        <p:scale>
          <a:sx n="58" d="100"/>
          <a:sy n="58" d="100"/>
        </p:scale>
        <p:origin x="6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1CAD75-6D50-E54F-A1D9-CFD43265D7B8}" type="datetimeFigureOut">
              <a:rPr lang="en-US" smtClean="0"/>
              <a:t>6/4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FAA4A5-DF24-324D-A382-350203FFA3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77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is is meant as a take-home reference for students. It consolidates insights from the podcast guests and the IPEC competencies to create a framework for </a:t>
            </a:r>
            <a:r>
              <a:rPr lang="en-US"/>
              <a:t>scaffolding students’ </a:t>
            </a:r>
            <a:r>
              <a:rPr lang="en-US" dirty="0"/>
              <a:t>future conversations with interprofessional colleagues during clerkship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FAA4A5-DF24-324D-A382-350203FFA3D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5140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9011B1-3312-7542-966F-CB12BB7630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34D9FA-4961-4C43-B99A-E380CA27AE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0A7905-54F9-0B48-83A4-ECF2EDC6C4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EFE3A4-3C5B-1644-9F34-C35BC7B99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108F5A-02F7-EB47-BEDC-0856C9126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433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C32E2-EE44-4C46-B596-99CF1A8647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A21088-0AF2-0848-A873-D8B1664039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0EACE-5374-5D47-B7CE-D848B3132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8D1EB3-C780-2746-9CF6-F9CDA2115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F7E80-4EAC-CC42-A09F-DB4C57D5C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313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F7F1705-EDBD-AE4F-9201-AAEFD848EE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21A779-ECA3-6C48-AC65-54952A2FFB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E6FA14-3E6C-664D-8D07-9760E587D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803155-604E-674F-898B-EAF970C60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92CAA9-A0A3-D746-A06B-24BA7E119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633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45E545-8A3F-2049-970E-8C65C1652A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1A589B-3227-7940-95BF-DAC8D37089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3B439-C39C-B344-BE79-354AE9979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3BF5F2-3A8B-764F-84CF-D6FF28174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AAB220-7880-6140-B4FB-CD21BB412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055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ABE8DA-7E99-4D43-87FA-BA55839662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870012-8A57-B94E-A681-7A6C2FA6E2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32A2F5-329B-B74E-82E8-6420FD09B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7F6AFB-81B8-A44F-B780-31F18C158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09F066-7102-D94D-BCE0-BCCABBEB6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388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B052D3-128F-9F44-A4B5-CEE83C189F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AD7DFD-D027-E640-8AAC-B126528F8B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925355-6F7E-6746-898B-A6E0ECB275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96E606-11BA-7E47-9169-DE5C5B062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E2B13B-DDF1-CF44-A7F8-0FEF16AA8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9E75EB-CEB2-2546-A679-6080FF139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933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8C07C8-BB30-5B49-A4BC-3650ED5F4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78FA37-5A50-084D-A599-3DE70994FC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09DBA8-9A9F-FE44-ABAC-03960A2E67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3CD20F-25F4-5B4C-9A2D-D48D764961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019FE3-B09C-0F44-BD6C-47D5886D29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355FA5-17D6-1A4A-89F0-3A31B9772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B7C465F-55CB-EE45-B058-0354A615F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5906A4-4FDD-E84D-BBF7-304920D32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167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A3122-D56C-AD4E-9DFE-02AE13A72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761565-0ACC-9246-A1B3-FEC8CD45F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2ABEF0-610A-0642-81DF-A319C870E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0635E3-2329-E74B-A69F-FA67116322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498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99AAAD-567F-DD4B-A2B9-A94794230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43B3FC-6963-EE43-9C26-120550B98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6BE4BC-2CC0-664F-88BC-D430AEBC6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611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249D29-3AFC-D34E-BF53-E54EA6F31A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AB828C-9D54-4D4B-BC33-D4F576C25B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AAA292-1C00-9440-8C7E-C365218DC8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79AD21-009B-6C45-AFC3-9A62AB63C3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EC2BAD-801E-1647-BF31-F6674B0C0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F23D34-91CB-F24F-AAA6-5EAC788A67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144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A81423-99EF-0E4D-B6D1-F25FCCE4D5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87B472-012B-A548-A439-5C02AA1622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4E0D81-0855-DD43-B925-972793A9A3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41106F-5D49-2D47-B60A-648119BF3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2CF83E-6CAA-124D-9BD4-79B6C2F97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29EABC-7E15-E24D-8B73-2A4736083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902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DF80A7-7F7F-B846-853E-1895297A9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79F38C-6886-ED41-A5FF-2B25C9741D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56AD67-B537-904B-B906-C7ADCDC54D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C3807-C1B6-3447-86C0-AF73CBACC222}" type="datetimeFigureOut">
              <a:rPr lang="en-US" smtClean="0"/>
              <a:t>6/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A35F40-36EB-C74E-ABF0-3E053D03EB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257DCD-804D-BE47-98C5-4B37B8A254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CB1D66-728A-B24E-9DCA-339D91F27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601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59E728-EC1F-A84E-BE6C-915D5C4081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"/>
            <a:ext cx="11973261" cy="978946"/>
          </a:xfrm>
        </p:spPr>
        <p:txBody>
          <a:bodyPr>
            <a:normAutofit/>
          </a:bodyPr>
          <a:lstStyle/>
          <a:p>
            <a:pPr algn="ctr"/>
            <a:r>
              <a:rPr lang="en-US" sz="2400" b="1" dirty="0"/>
              <a:t>Student Framework: Continued Conversations Around Interprofessional Collabor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390743-9BA3-B24D-9E85-9710B2EE83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16945" y="1270035"/>
            <a:ext cx="11854927" cy="54517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600" dirty="0"/>
              <a:t>Prior to the conversation with an interprofessional colleague, reflect on the collaboration:</a:t>
            </a:r>
          </a:p>
          <a:p>
            <a:pPr lvl="1"/>
            <a:r>
              <a:rPr lang="en-US" sz="1600" dirty="0"/>
              <a:t>From your perspective, was the collaboration successful? What went well? What could have been improved?</a:t>
            </a:r>
          </a:p>
          <a:p>
            <a:pPr lvl="1"/>
            <a:r>
              <a:rPr lang="en-US" sz="1600" dirty="0"/>
              <a:t>Are their specific aspects around which you want specific feedback from your interprofessional colleague?</a:t>
            </a:r>
          </a:p>
          <a:p>
            <a:pPr lvl="1"/>
            <a:r>
              <a:rPr lang="en-US" sz="1600" dirty="0"/>
              <a:t>Did you learn anything new about the health care profession through the collaboration? Do you have outstanding questions?</a:t>
            </a:r>
          </a:p>
          <a:p>
            <a:pPr marL="457200" lvl="1" indent="0">
              <a:buNone/>
            </a:pPr>
            <a:endParaRPr lang="en-US" sz="1600" dirty="0"/>
          </a:p>
          <a:p>
            <a:pPr marL="0" indent="0">
              <a:buNone/>
            </a:pPr>
            <a:r>
              <a:rPr lang="en-US" sz="1600" dirty="0"/>
              <a:t>With your interprofessional colleague, jointly reflect on the interaction from the perspective of the IPEC competencies:</a:t>
            </a:r>
          </a:p>
          <a:p>
            <a:pPr lvl="1"/>
            <a:r>
              <a:rPr lang="en-US" sz="1600" dirty="0"/>
              <a:t>How are your values similar or different from interprofessional colleagues? How might these similarities (differences) enhance patient care?</a:t>
            </a:r>
          </a:p>
          <a:p>
            <a:pPr lvl="1"/>
            <a:r>
              <a:rPr lang="en-US" sz="1600" dirty="0"/>
              <a:t>How did these interactions impact your understanding of the roles and responsibilities of interprofessional colleagues? How do other team members complement your own abilities?</a:t>
            </a:r>
          </a:p>
          <a:p>
            <a:pPr lvl="1"/>
            <a:r>
              <a:rPr lang="en-US" sz="1600" dirty="0"/>
              <a:t>Can you identify any moments of interprofessional conflict? How were these handled?</a:t>
            </a:r>
          </a:p>
          <a:p>
            <a:pPr lvl="1"/>
            <a:r>
              <a:rPr lang="en-US" sz="1600" dirty="0"/>
              <a:t>How does language used when speaking to or about interprofessional colleagues contribute to or detract from team functioning?</a:t>
            </a:r>
          </a:p>
          <a:p>
            <a:pPr lvl="1"/>
            <a:endParaRPr lang="en-US" sz="1600" dirty="0"/>
          </a:p>
          <a:p>
            <a:pPr marL="0" indent="0">
              <a:buNone/>
            </a:pPr>
            <a:r>
              <a:rPr lang="en-US" sz="1600" dirty="0"/>
              <a:t>Tips for Initiating Conversations with Interprofessional Colleagues:</a:t>
            </a:r>
          </a:p>
          <a:p>
            <a:pPr lvl="1"/>
            <a:r>
              <a:rPr lang="en-US" sz="1600" dirty="0"/>
              <a:t>Approach colleagues with curiosity about their profession and perspective</a:t>
            </a:r>
          </a:p>
          <a:p>
            <a:pPr lvl="1"/>
            <a:r>
              <a:rPr lang="en-US" sz="1600" dirty="0"/>
              <a:t>Clearly express your desire to learn and improve</a:t>
            </a:r>
          </a:p>
          <a:p>
            <a:pPr lvl="1"/>
            <a:r>
              <a:rPr lang="en-US" sz="1600" dirty="0"/>
              <a:t>Identify a mutually agreeable time; find a place that will minimize interruptions</a:t>
            </a:r>
            <a:endParaRPr lang="en-US" sz="2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0AD5C7C-CA50-C041-955A-710818A449D3}"/>
              </a:ext>
            </a:extLst>
          </p:cNvPr>
          <p:cNvSpPr txBox="1"/>
          <p:nvPr/>
        </p:nvSpPr>
        <p:spPr>
          <a:xfrm>
            <a:off x="96819" y="667287"/>
            <a:ext cx="120951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/>
              <a:t>The reflections and talking points can serve as a guide for a conversation around interprofessional collaboration. 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ECCB7F4-A007-EB42-A365-1C82FAF9E378}"/>
              </a:ext>
            </a:extLst>
          </p:cNvPr>
          <p:cNvCxnSpPr/>
          <p:nvPr/>
        </p:nvCxnSpPr>
        <p:spPr>
          <a:xfrm>
            <a:off x="96819" y="1109222"/>
            <a:ext cx="118764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93666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84</TotalTime>
  <Words>268</Words>
  <Application>Microsoft Macintosh PowerPoint</Application>
  <PresentationFormat>Widescreen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tudent Framework: Continued Conversations Around Interprofessional Collabor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sey Miller</dc:creator>
  <cp:lastModifiedBy>Kelsey Miller</cp:lastModifiedBy>
  <cp:revision>21</cp:revision>
  <dcterms:created xsi:type="dcterms:W3CDTF">2020-04-13T17:33:41Z</dcterms:created>
  <dcterms:modified xsi:type="dcterms:W3CDTF">2021-06-04T19:27:50Z</dcterms:modified>
</cp:coreProperties>
</file>